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</p:sldIdLst>
  <p:sldSz cx="14630400" cy="9144000"/>
  <p:notesSz cx="146304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-1032" y="-101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801052" y="2342515"/>
            <a:ext cx="9078595" cy="158686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602105" y="4231640"/>
            <a:ext cx="7476490" cy="18891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534035" y="1737995"/>
            <a:ext cx="4646104" cy="49872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5500560" y="1737995"/>
            <a:ext cx="4646104" cy="49872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534035" y="302260"/>
            <a:ext cx="9612630" cy="1209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534035" y="1737995"/>
            <a:ext cx="9612630" cy="498729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631438" y="7027545"/>
            <a:ext cx="3417824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534035" y="7027545"/>
            <a:ext cx="2456561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4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7690104" y="7027545"/>
            <a:ext cx="2456561" cy="377825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>
            <a:spLocks noChangeAspect="1"/>
          </p:cNvSpPr>
          <p:nvPr/>
        </p:nvSpPr>
        <p:spPr>
          <a:xfrm>
            <a:off x="1617" y="5295"/>
            <a:ext cx="14633106" cy="3652305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Rettangolo 2"/>
          <p:cNvSpPr/>
          <p:nvPr/>
        </p:nvSpPr>
        <p:spPr>
          <a:xfrm>
            <a:off x="76200" y="4038600"/>
            <a:ext cx="10287000" cy="3046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iecharts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howing the percentage of reads mapped to exon, introns and intergenic regions in the </a:t>
            </a:r>
            <a:r>
              <a:rPr lang="en-US" sz="12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abidopsis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genome. </a:t>
            </a:r>
            <a:endParaRPr lang="it-IT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ADAF27E465E9D544BA6E456B7694FCBD" ma:contentTypeVersion="13" ma:contentTypeDescription="Creare un nuovo documento." ma:contentTypeScope="" ma:versionID="fe8124e4c94682e6a433aeaf1fd84dc0">
  <xsd:schema xmlns:xsd="http://www.w3.org/2001/XMLSchema" xmlns:xs="http://www.w3.org/2001/XMLSchema" xmlns:p="http://schemas.microsoft.com/office/2006/metadata/properties" xmlns:ns3="c7cae103-93ad-4c93-a5ef-67d5c5e21413" xmlns:ns4="d98f46d9-7d05-4798-ad0b-6df40240d227" targetNamespace="http://schemas.microsoft.com/office/2006/metadata/properties" ma:root="true" ma:fieldsID="bf6736f76d33aefcf40cd35bb86e24e2" ns3:_="" ns4:_="">
    <xsd:import namespace="c7cae103-93ad-4c93-a5ef-67d5c5e21413"/>
    <xsd:import namespace="d98f46d9-7d05-4798-ad0b-6df40240d227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ServiceOCR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7cae103-93ad-4c93-a5ef-67d5c5e2141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4" nillable="true" ma:displayName="Location" ma:internalName="MediaServiceLocation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98f46d9-7d05-4798-ad0b-6df40240d227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Condivis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Condiviso con dettagli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Hash suggerimento condivisione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7BFF02C-DF3C-4459-8092-4DCD70544AF7}">
  <ds:schemaRefs>
    <ds:schemaRef ds:uri="http://schemas.microsoft.com/office/2006/metadata/properties"/>
    <ds:schemaRef ds:uri="c7cae103-93ad-4c93-a5ef-67d5c5e21413"/>
    <ds:schemaRef ds:uri="http://schemas.microsoft.com/office/2006/documentManagement/types"/>
    <ds:schemaRef ds:uri="http://purl.org/dc/elements/1.1/"/>
    <ds:schemaRef ds:uri="http://purl.org/dc/dcmitype/"/>
    <ds:schemaRef ds:uri="d98f46d9-7d05-4798-ad0b-6df40240d227"/>
    <ds:schemaRef ds:uri="http://www.w3.org/XML/1998/namespace"/>
    <ds:schemaRef ds:uri="http://purl.org/dc/terms/"/>
    <ds:schemaRef ds:uri="http://schemas.microsoft.com/office/infopath/2007/PartnerControls"/>
    <ds:schemaRef ds:uri="http://schemas.openxmlformats.org/package/2006/metadata/core-properties"/>
  </ds:schemaRefs>
</ds:datastoreItem>
</file>

<file path=customXml/itemProps2.xml><?xml version="1.0" encoding="utf-8"?>
<ds:datastoreItem xmlns:ds="http://schemas.openxmlformats.org/officeDocument/2006/customXml" ds:itemID="{56C11803-18AC-4A19-AF5D-8405B81E3C9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A87ABB8-9142-4DC9-B272-BBF34D17C5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7cae103-93ad-4c93-a5ef-67d5c5e21413"/>
    <ds:schemaRef ds:uri="d98f46d9-7d05-4798-ad0b-6df40240d227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Words>23</Words>
  <Application>Microsoft Office PowerPoint</Application>
  <PresentationFormat>Personalizzato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Office Them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asquale Termolino</dc:creator>
  <cp:lastModifiedBy>Lenovo</cp:lastModifiedBy>
  <cp:revision>6</cp:revision>
  <dcterms:created xsi:type="dcterms:W3CDTF">2020-12-04T10:14:17Z</dcterms:created>
  <dcterms:modified xsi:type="dcterms:W3CDTF">2020-12-04T18:08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LastSaved">
    <vt:filetime>2020-12-04T00:00:00Z</vt:filetime>
  </property>
  <property fmtid="{D5CDD505-2E9C-101B-9397-08002B2CF9AE}" pid="3" name="ContentTypeId">
    <vt:lpwstr>0x010100ADAF27E465E9D544BA6E456B7694FCBD</vt:lpwstr>
  </property>
</Properties>
</file>